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Alcím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u-HU" smtClean="0"/>
              <a:t>Alcím mintájának szerkesztése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031A2-736E-469C-A0FF-CCCE76BC9C8B}" type="datetimeFigureOut">
              <a:rPr lang="hu-HU" smtClean="0"/>
              <a:t>2022. 11. 14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66E80-B347-49D5-8656-0FBAA6BB5CE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8224693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031A2-736E-469C-A0FF-CCCE76BC9C8B}" type="datetimeFigureOut">
              <a:rPr lang="hu-HU" smtClean="0"/>
              <a:t>2022. 11. 14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66E80-B347-49D5-8656-0FBAA6BB5CE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1746455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031A2-736E-469C-A0FF-CCCE76BC9C8B}" type="datetimeFigureOut">
              <a:rPr lang="hu-HU" smtClean="0"/>
              <a:t>2022. 11. 14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66E80-B347-49D5-8656-0FBAA6BB5CE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672059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031A2-736E-469C-A0FF-CCCE76BC9C8B}" type="datetimeFigureOut">
              <a:rPr lang="hu-HU" smtClean="0"/>
              <a:t>2022. 11. 14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66E80-B347-49D5-8656-0FBAA6BB5CE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361981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031A2-736E-469C-A0FF-CCCE76BC9C8B}" type="datetimeFigureOut">
              <a:rPr lang="hu-HU" smtClean="0"/>
              <a:t>2022. 11. 14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66E80-B347-49D5-8656-0FBAA6BB5CE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9577852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Tartalom helye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031A2-736E-469C-A0FF-CCCE76BC9C8B}" type="datetimeFigureOut">
              <a:rPr lang="hu-HU" smtClean="0"/>
              <a:t>2022. 11. 14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66E80-B347-49D5-8656-0FBAA6BB5CE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5235063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5" name="Szöveg hely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6" name="Tartalom helye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7" name="Dátum hely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031A2-736E-469C-A0FF-CCCE76BC9C8B}" type="datetimeFigureOut">
              <a:rPr lang="hu-HU" smtClean="0"/>
              <a:t>2022. 11. 14.</a:t>
            </a:fld>
            <a:endParaRPr lang="hu-HU"/>
          </a:p>
        </p:txBody>
      </p:sp>
      <p:sp>
        <p:nvSpPr>
          <p:cNvPr id="8" name="Élőláb hely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Dia számának hely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66E80-B347-49D5-8656-0FBAA6BB5CE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7706944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Dátum hely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031A2-736E-469C-A0FF-CCCE76BC9C8B}" type="datetimeFigureOut">
              <a:rPr lang="hu-HU" smtClean="0"/>
              <a:t>2022. 11. 14.</a:t>
            </a:fld>
            <a:endParaRPr lang="hu-HU"/>
          </a:p>
        </p:txBody>
      </p:sp>
      <p:sp>
        <p:nvSpPr>
          <p:cNvPr id="4" name="Élőláb hely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Dia számának hely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66E80-B347-49D5-8656-0FBAA6BB5CE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0081437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031A2-736E-469C-A0FF-CCCE76BC9C8B}" type="datetimeFigureOut">
              <a:rPr lang="hu-HU" smtClean="0"/>
              <a:t>2022. 11. 14.</a:t>
            </a:fld>
            <a:endParaRPr lang="hu-HU"/>
          </a:p>
        </p:txBody>
      </p:sp>
      <p:sp>
        <p:nvSpPr>
          <p:cNvPr id="3" name="Élőláb hely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Dia számának hely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66E80-B347-49D5-8656-0FBAA6BB5CE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0624038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031A2-736E-469C-A0FF-CCCE76BC9C8B}" type="datetimeFigureOut">
              <a:rPr lang="hu-HU" smtClean="0"/>
              <a:t>2022. 11. 14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66E80-B347-49D5-8656-0FBAA6BB5CE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6880494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Kép hely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u-HU"/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031A2-736E-469C-A0FF-CCCE76BC9C8B}" type="datetimeFigureOut">
              <a:rPr lang="hu-HU" smtClean="0"/>
              <a:t>2022. 11. 14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66E80-B347-49D5-8656-0FBAA6BB5CE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2632080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C031A2-736E-469C-A0FF-CCCE76BC9C8B}" type="datetimeFigureOut">
              <a:rPr lang="hu-HU" smtClean="0"/>
              <a:t>2022. 11. 14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C66E80-B347-49D5-8656-0FBAA6BB5CE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3255949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u-H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Kép 3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176" t="9606" r="13852" b="436"/>
          <a:stretch/>
        </p:blipFill>
        <p:spPr>
          <a:xfrm>
            <a:off x="2577975" y="936000"/>
            <a:ext cx="1619251" cy="1619250"/>
          </a:xfrm>
          <a:prstGeom prst="rect">
            <a:avLst/>
          </a:prstGeom>
        </p:spPr>
      </p:pic>
      <p:pic>
        <p:nvPicPr>
          <p:cNvPr id="5" name="Kép 4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314" t="3838" r="15712" b="6204"/>
          <a:stretch/>
        </p:blipFill>
        <p:spPr>
          <a:xfrm>
            <a:off x="2577975" y="2700000"/>
            <a:ext cx="1619251" cy="1619250"/>
          </a:xfrm>
          <a:prstGeom prst="rect">
            <a:avLst/>
          </a:prstGeom>
        </p:spPr>
      </p:pic>
      <p:pic>
        <p:nvPicPr>
          <p:cNvPr id="6" name="Kép 5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262" t="5955" r="13743" b="4087"/>
          <a:stretch/>
        </p:blipFill>
        <p:spPr>
          <a:xfrm>
            <a:off x="849975" y="936000"/>
            <a:ext cx="1619828" cy="1619249"/>
          </a:xfrm>
          <a:prstGeom prst="rect">
            <a:avLst/>
          </a:prstGeom>
        </p:spPr>
      </p:pic>
      <p:pic>
        <p:nvPicPr>
          <p:cNvPr id="7" name="Kép 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942" t="7632" r="16087" b="2410"/>
          <a:stretch/>
        </p:blipFill>
        <p:spPr>
          <a:xfrm>
            <a:off x="849975" y="2700000"/>
            <a:ext cx="1619250" cy="1619250"/>
          </a:xfrm>
          <a:prstGeom prst="rect">
            <a:avLst/>
          </a:prstGeom>
        </p:spPr>
      </p:pic>
      <p:sp>
        <p:nvSpPr>
          <p:cNvPr id="8" name="Szövegdoboz 7"/>
          <p:cNvSpPr txBox="1"/>
          <p:nvPr/>
        </p:nvSpPr>
        <p:spPr>
          <a:xfrm>
            <a:off x="2074967" y="216000"/>
            <a:ext cx="941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ucose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Szövegdoboz 8"/>
          <p:cNvSpPr txBox="1"/>
          <p:nvPr/>
        </p:nvSpPr>
        <p:spPr>
          <a:xfrm>
            <a:off x="1317975" y="576000"/>
            <a:ext cx="7048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TES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Szövegdoboz 9"/>
          <p:cNvSpPr txBox="1"/>
          <p:nvPr/>
        </p:nvSpPr>
        <p:spPr>
          <a:xfrm>
            <a:off x="3016250" y="576000"/>
            <a:ext cx="7048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TES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Szövegdoboz 10"/>
          <p:cNvSpPr txBox="1"/>
          <p:nvPr/>
        </p:nvSpPr>
        <p:spPr>
          <a:xfrm>
            <a:off x="1067838" y="1006823"/>
            <a:ext cx="122982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 additives</a:t>
            </a:r>
            <a:endParaRPr lang="en-US" sz="1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Szövegdoboz 11"/>
          <p:cNvSpPr txBox="1"/>
          <p:nvPr/>
        </p:nvSpPr>
        <p:spPr>
          <a:xfrm>
            <a:off x="962133" y="2700000"/>
            <a:ext cx="14221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.04 </a:t>
            </a:r>
            <a:r>
              <a:rPr lang="en-US" sz="1600" dirty="0" err="1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MSB</a:t>
            </a:r>
            <a:endParaRPr lang="en-US" sz="1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Szövegdoboz 12"/>
          <p:cNvSpPr txBox="1"/>
          <p:nvPr/>
        </p:nvSpPr>
        <p:spPr>
          <a:xfrm>
            <a:off x="2855747" y="2700000"/>
            <a:ext cx="11079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 </a:t>
            </a:r>
            <a:r>
              <a:rPr lang="en-US" sz="1600" dirty="0" err="1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DFP</a:t>
            </a:r>
            <a:endParaRPr lang="en-US" sz="1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Szövegdoboz 13"/>
          <p:cNvSpPr txBox="1"/>
          <p:nvPr/>
        </p:nvSpPr>
        <p:spPr>
          <a:xfrm>
            <a:off x="2789072" y="1006823"/>
            <a:ext cx="122982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 additives</a:t>
            </a:r>
            <a:endParaRPr lang="en-US" sz="1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5" name="Kép 14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600" t="5651" r="13427" b="4391"/>
          <a:stretch/>
        </p:blipFill>
        <p:spPr>
          <a:xfrm>
            <a:off x="4449975" y="2700000"/>
            <a:ext cx="1619250" cy="1619250"/>
          </a:xfrm>
          <a:prstGeom prst="rect">
            <a:avLst/>
          </a:prstGeom>
        </p:spPr>
      </p:pic>
      <p:pic>
        <p:nvPicPr>
          <p:cNvPr id="16" name="Kép 15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516" t="7658" r="12511" b="2383"/>
          <a:stretch/>
        </p:blipFill>
        <p:spPr>
          <a:xfrm>
            <a:off x="4449975" y="936000"/>
            <a:ext cx="1619250" cy="1619250"/>
          </a:xfrm>
          <a:prstGeom prst="rect">
            <a:avLst/>
          </a:prstGeom>
        </p:spPr>
      </p:pic>
      <p:pic>
        <p:nvPicPr>
          <p:cNvPr id="17" name="Kép 16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907" t="5997" r="15121" b="4045"/>
          <a:stretch/>
        </p:blipFill>
        <p:spPr>
          <a:xfrm>
            <a:off x="6213975" y="936000"/>
            <a:ext cx="1619251" cy="1619250"/>
          </a:xfrm>
          <a:prstGeom prst="rect">
            <a:avLst/>
          </a:prstGeom>
        </p:spPr>
      </p:pic>
      <p:pic>
        <p:nvPicPr>
          <p:cNvPr id="18" name="Kép 17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842" t="4525" r="16185" b="5518"/>
          <a:stretch/>
        </p:blipFill>
        <p:spPr>
          <a:xfrm>
            <a:off x="6213975" y="2700000"/>
            <a:ext cx="1619251" cy="1619250"/>
          </a:xfrm>
          <a:prstGeom prst="rect">
            <a:avLst/>
          </a:prstGeom>
        </p:spPr>
      </p:pic>
      <p:sp>
        <p:nvSpPr>
          <p:cNvPr id="19" name="Szövegdoboz 18"/>
          <p:cNvSpPr txBox="1"/>
          <p:nvPr/>
        </p:nvSpPr>
        <p:spPr>
          <a:xfrm>
            <a:off x="4677813" y="1006823"/>
            <a:ext cx="122982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 additives</a:t>
            </a:r>
            <a:endParaRPr lang="en-US" sz="1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Szövegdoboz 19"/>
          <p:cNvSpPr txBox="1"/>
          <p:nvPr/>
        </p:nvSpPr>
        <p:spPr>
          <a:xfrm>
            <a:off x="4581633" y="2700000"/>
            <a:ext cx="14221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.04 </a:t>
            </a:r>
            <a:r>
              <a:rPr lang="en-US" sz="1600" dirty="0" err="1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MSB</a:t>
            </a:r>
            <a:endParaRPr lang="en-US" sz="1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Szövegdoboz 20"/>
          <p:cNvSpPr txBox="1"/>
          <p:nvPr/>
        </p:nvSpPr>
        <p:spPr>
          <a:xfrm>
            <a:off x="6484772" y="2700000"/>
            <a:ext cx="11079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 </a:t>
            </a:r>
            <a:r>
              <a:rPr lang="en-US" sz="1600" dirty="0" err="1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DFP</a:t>
            </a:r>
            <a:endParaRPr lang="en-US" sz="1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Szövegdoboz 21"/>
          <p:cNvSpPr txBox="1"/>
          <p:nvPr/>
        </p:nvSpPr>
        <p:spPr>
          <a:xfrm>
            <a:off x="6399047" y="1006823"/>
            <a:ext cx="122982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 additives</a:t>
            </a:r>
            <a:endParaRPr lang="en-US" sz="1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Szövegdoboz 22"/>
          <p:cNvSpPr txBox="1"/>
          <p:nvPr/>
        </p:nvSpPr>
        <p:spPr>
          <a:xfrm>
            <a:off x="5237267" y="216000"/>
            <a:ext cx="19175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ucose + peptone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Szövegdoboz 23"/>
          <p:cNvSpPr txBox="1"/>
          <p:nvPr/>
        </p:nvSpPr>
        <p:spPr>
          <a:xfrm>
            <a:off x="4940300" y="576000"/>
            <a:ext cx="7048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TES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Szövegdoboz 24"/>
          <p:cNvSpPr txBox="1"/>
          <p:nvPr/>
        </p:nvSpPr>
        <p:spPr>
          <a:xfrm>
            <a:off x="6683375" y="576000"/>
            <a:ext cx="7048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TES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6" name="Kép 25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51" t="9548" r="19588" b="2611"/>
          <a:stretch/>
        </p:blipFill>
        <p:spPr>
          <a:xfrm>
            <a:off x="8085975" y="936000"/>
            <a:ext cx="1620000" cy="1620000"/>
          </a:xfrm>
          <a:prstGeom prst="rect">
            <a:avLst/>
          </a:prstGeom>
        </p:spPr>
      </p:pic>
      <p:pic>
        <p:nvPicPr>
          <p:cNvPr id="27" name="Kép 26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492" t="6346" r="16848" b="5749"/>
          <a:stretch/>
        </p:blipFill>
        <p:spPr>
          <a:xfrm>
            <a:off x="9830925" y="2700000"/>
            <a:ext cx="1620000" cy="1618503"/>
          </a:xfrm>
          <a:prstGeom prst="rect">
            <a:avLst/>
          </a:prstGeom>
        </p:spPr>
      </p:pic>
      <p:pic>
        <p:nvPicPr>
          <p:cNvPr id="28" name="Kép 27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153" t="4827" r="16197" b="7201"/>
          <a:stretch/>
        </p:blipFill>
        <p:spPr>
          <a:xfrm>
            <a:off x="9830925" y="936000"/>
            <a:ext cx="1620000" cy="1620000"/>
          </a:xfrm>
          <a:prstGeom prst="rect">
            <a:avLst/>
          </a:prstGeom>
        </p:spPr>
      </p:pic>
      <p:pic>
        <p:nvPicPr>
          <p:cNvPr id="29" name="Kép 28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838" t="7669" r="14511" b="4356"/>
          <a:stretch/>
        </p:blipFill>
        <p:spPr>
          <a:xfrm>
            <a:off x="8085975" y="2700000"/>
            <a:ext cx="1620000" cy="1619999"/>
          </a:xfrm>
          <a:prstGeom prst="rect">
            <a:avLst/>
          </a:prstGeom>
        </p:spPr>
      </p:pic>
      <p:sp>
        <p:nvSpPr>
          <p:cNvPr id="34" name="Szövegdoboz 33"/>
          <p:cNvSpPr txBox="1"/>
          <p:nvPr/>
        </p:nvSpPr>
        <p:spPr>
          <a:xfrm>
            <a:off x="8556975" y="576000"/>
            <a:ext cx="7048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TES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Szövegdoboz 34"/>
          <p:cNvSpPr txBox="1"/>
          <p:nvPr/>
        </p:nvSpPr>
        <p:spPr>
          <a:xfrm>
            <a:off x="10302875" y="576000"/>
            <a:ext cx="7048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TES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Szövegdoboz 35"/>
          <p:cNvSpPr txBox="1"/>
          <p:nvPr/>
        </p:nvSpPr>
        <p:spPr>
          <a:xfrm>
            <a:off x="9304442" y="216000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ptone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Szövegdoboz 36"/>
          <p:cNvSpPr txBox="1"/>
          <p:nvPr/>
        </p:nvSpPr>
        <p:spPr>
          <a:xfrm>
            <a:off x="8325888" y="1008000"/>
            <a:ext cx="122982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 additives</a:t>
            </a:r>
            <a:endParaRPr lang="en-US" sz="1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Szövegdoboz 37"/>
          <p:cNvSpPr txBox="1"/>
          <p:nvPr/>
        </p:nvSpPr>
        <p:spPr>
          <a:xfrm>
            <a:off x="10047122" y="1008000"/>
            <a:ext cx="122982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 additives</a:t>
            </a:r>
            <a:endParaRPr lang="en-US" sz="1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Szövegdoboz 40"/>
          <p:cNvSpPr txBox="1"/>
          <p:nvPr/>
        </p:nvSpPr>
        <p:spPr>
          <a:xfrm>
            <a:off x="8210658" y="2700000"/>
            <a:ext cx="14221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.04 </a:t>
            </a:r>
            <a:r>
              <a:rPr lang="en-US" sz="1600" dirty="0" err="1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MSB</a:t>
            </a:r>
            <a:endParaRPr lang="en-US" sz="1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Szövegdoboz 41"/>
          <p:cNvSpPr txBox="1"/>
          <p:nvPr/>
        </p:nvSpPr>
        <p:spPr>
          <a:xfrm>
            <a:off x="10113797" y="2700000"/>
            <a:ext cx="11079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 </a:t>
            </a:r>
            <a:r>
              <a:rPr lang="en-US" sz="1600" dirty="0" err="1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DFP</a:t>
            </a:r>
            <a:endParaRPr lang="en-US" sz="1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Szövegdoboz 42"/>
          <p:cNvSpPr txBox="1"/>
          <p:nvPr/>
        </p:nvSpPr>
        <p:spPr>
          <a:xfrm>
            <a:off x="161925" y="5000625"/>
            <a:ext cx="1182859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3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ffect of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nadione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odium bisulfite (MSB) and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feriprone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DFP) on the growth of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. fumigatus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f293.</a:t>
            </a:r>
            <a:endParaRPr lang="hu-HU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ultures were cultivated at 37 °C for 5 days on </a:t>
            </a:r>
            <a:r>
              <a:rPr lang="en-US" sz="1200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arrat</a:t>
            </a:r>
            <a:r>
              <a:rPr lang="hu-HU" sz="120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US" sz="120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’s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itrate agar plates supplemented (+TES), or not (-TES), with trace elements solution. Representative photos of four biological replicates are presented. Petri-dish diameter is 85 mm.</a:t>
            </a:r>
            <a:endParaRPr lang="hu-HU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25000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</TotalTime>
  <Words>117</Words>
  <Application>Microsoft Office PowerPoint</Application>
  <PresentationFormat>Szélesvásznú</PresentationFormat>
  <Paragraphs>23</Paragraphs>
  <Slides>1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4</vt:i4>
      </vt:variant>
      <vt:variant>
        <vt:lpstr>Téma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-téma</vt:lpstr>
      <vt:lpstr>PowerPoint bemutat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bemutató</dc:title>
  <dc:creator>Dr Emri Tamás</dc:creator>
  <cp:lastModifiedBy>Dr Emri Tamás</cp:lastModifiedBy>
  <cp:revision>13</cp:revision>
  <dcterms:created xsi:type="dcterms:W3CDTF">2022-07-18T07:27:50Z</dcterms:created>
  <dcterms:modified xsi:type="dcterms:W3CDTF">2022-11-14T18:29:08Z</dcterms:modified>
</cp:coreProperties>
</file>